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42064-3CA7-439E-BC40-4CF4267CD1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E2097-F52B-4210-BC83-2740FB63CF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6EF5AB-3377-4B8A-9753-CD38EE841C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AFCDD-50BB-40B0-8B06-B1400BBBA3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BCC83-A094-466F-A468-ABF5906423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63942-295C-49DF-8BDF-CEC75A97BF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6331C-B0BA-4950-8366-325447B3FB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6DE3A-74C0-4DF1-A5E6-F39AC2C18A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BA160-A2FA-4135-8000-8E83D1781A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A5BD2-B88E-4154-AD81-FFEAB7A956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DAC6D-1995-405E-85FA-65AB5FE118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7858A-5A44-44B4-97C1-E5DD801A8F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4B740C-AA37-4805-B28D-4FE4A0616400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hyperlink" Target="http://www.slicer.org/" TargetMode="Externa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9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4 CuadroTexto"/>
          <p:cNvSpPr/>
          <p:nvPr/>
        </p:nvSpPr>
        <p:spPr>
          <a:xfrm>
            <a:off x="42480" y="285840"/>
            <a:ext cx="904284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1.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Converting Dicom Images to Nifti format with MRIcron (Dicom to Nifti converter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 FSL (4D Nifti nii) as the Output format and Drag and drop the first Dicom imag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f the BRAIN T1 MRI data to the program. Then repeat the process for the Post-Implant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T imag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5 CuadroTexto"/>
          <p:cNvSpPr/>
          <p:nvPr/>
        </p:nvSpPr>
        <p:spPr>
          <a:xfrm>
            <a:off x="2472840" y="4500720"/>
            <a:ext cx="43153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wo Nifti  4D volumes will be generated 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1BrainMRI.n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stImplantCT.n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"/>
          <p:cNvSpPr/>
          <p:nvPr/>
        </p:nvSpPr>
        <p:spPr>
          <a:xfrm>
            <a:off x="999360" y="6491160"/>
            <a:ext cx="714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 Unicode MS"/>
              </a:rPr>
              <a:t>MRIcron, version 1, April 2010. Available at (http://www.mccauslandcenter.sc.edu/mricro/mricron/install.html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6" descr=""/>
          <p:cNvPicPr/>
          <p:nvPr/>
        </p:nvPicPr>
        <p:blipFill>
          <a:blip r:embed="rId1"/>
          <a:stretch/>
        </p:blipFill>
        <p:spPr>
          <a:xfrm>
            <a:off x="133200" y="2362320"/>
            <a:ext cx="8877600" cy="1352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2 Rectángulo"/>
          <p:cNvSpPr/>
          <p:nvPr/>
        </p:nvSpPr>
        <p:spPr>
          <a:xfrm>
            <a:off x="142920" y="2928960"/>
            <a:ext cx="892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31640" indent="-322200">
              <a:tabLst>
                <a:tab algn="l" pos="0"/>
                <a:tab algn="l" pos="431640"/>
                <a:tab algn="l" pos="536400"/>
                <a:tab algn="l" pos="985680"/>
                <a:tab algn="l" pos="1434960"/>
                <a:tab algn="l" pos="1884240"/>
                <a:tab algn="l" pos="2333520"/>
                <a:tab algn="l" pos="2782800"/>
                <a:tab algn="l" pos="3232080"/>
                <a:tab algn="l" pos="3681360"/>
                <a:tab algn="l" pos="4130640"/>
                <a:tab algn="l" pos="4579920"/>
                <a:tab algn="l" pos="5029200"/>
                <a:tab algn="l" pos="5478480"/>
                <a:tab algn="l" pos="5927760"/>
                <a:tab algn="l" pos="6377040"/>
                <a:tab algn="l" pos="6826320"/>
                <a:tab algn="l" pos="7275600"/>
                <a:tab algn="l" pos="7724880"/>
                <a:tab algn="l" pos="8174160"/>
                <a:tab algn="l" pos="8623440"/>
                <a:tab algn="l" pos="9072720"/>
                <a:tab algn="l" pos="9410760"/>
                <a:tab algn="l" pos="10134720"/>
              </a:tabLst>
            </a:pPr>
            <a:r>
              <a:rPr b="1" i="1" lang="es-AR" sz="1400" spc="-1" strike="noStrike">
                <a:solidFill>
                  <a:srgbClr val="000000"/>
                </a:solidFill>
                <a:latin typeface="Arial"/>
              </a:rPr>
              <a:t>/usr/local/freesurfer/subjects/subject1$ recon-all -s OUTPUTFOLDERNAME -i Subject1BrainT1.nii -al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6" descr=""/>
          <p:cNvPicPr/>
          <p:nvPr/>
        </p:nvPicPr>
        <p:blipFill>
          <a:blip r:embed="rId1"/>
          <a:srcRect l="20312" t="31668" r="6772" b="30836"/>
          <a:stretch/>
        </p:blipFill>
        <p:spPr>
          <a:xfrm>
            <a:off x="0" y="3286080"/>
            <a:ext cx="9144000" cy="2938680"/>
          </a:xfrm>
          <a:prstGeom prst="rect">
            <a:avLst/>
          </a:prstGeom>
          <a:ln w="0">
            <a:noFill/>
          </a:ln>
        </p:spPr>
      </p:pic>
      <p:sp>
        <p:nvSpPr>
          <p:cNvPr id="47" name="11 CuadroTexto"/>
          <p:cNvSpPr/>
          <p:nvPr/>
        </p:nvSpPr>
        <p:spPr>
          <a:xfrm>
            <a:off x="71280" y="66600"/>
            <a:ext cx="9230040" cy="28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2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Freesurfer Automatic segmentation and labeling of cerebral cortex, Extra-cerebral </a:t>
            </a:r>
            <a:br>
              <a:rPr sz="1800"/>
            </a:b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structures extraction and Pial surface 3D reconstruction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se the previously Nifti converted Brain T1 MRI  to automatically generate skull strip, 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rtical parcellations, segmentation and pial 3D surface datasets.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ll the necessary  images are obtained running the following command line in 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econfigured Linux system with freesurfer (See the online instructions for installatio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d hardware requirements at http://surfer.nmr.mgh.harvard.edu/.) 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akes about 20 Hs, using a Quad Core PC, 2.5 Mhz and 8 GB RAM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12 CuadroTexto"/>
          <p:cNvSpPr/>
          <p:nvPr/>
        </p:nvSpPr>
        <p:spPr>
          <a:xfrm>
            <a:off x="-1080" y="6215040"/>
            <a:ext cx="92808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ypical Freesurfer´s output folder showing the location of the required file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(Brain.mgz = Skul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tripped, T1.mgz = Original Brain T1, wparc.mgz = Parcellations, LH and RH Pial = 3D pial surface models)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3 CuadroTexto"/>
          <p:cNvSpPr/>
          <p:nvPr/>
        </p:nvSpPr>
        <p:spPr>
          <a:xfrm>
            <a:off x="54000" y="285840"/>
            <a:ext cx="905328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3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D Slicer Visualiza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1. Loading data to 3DSlicer 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oad all the previously described images including the Freesurfer´s required output and 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st-Implant CT datasets into 3DSlicer using File/Add Dat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9 CuadroTexto"/>
          <p:cNvSpPr/>
          <p:nvPr/>
        </p:nvSpPr>
        <p:spPr>
          <a:xfrm>
            <a:off x="164160" y="5429160"/>
            <a:ext cx="88948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lect “Show Options” to enable files description; set all to “Centered” and then select 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Label Map box for the WMPARC.MGZ volume as shown above. Then click OK to </a:t>
            </a:r>
            <a:br>
              <a:rPr sz="1800"/>
            </a:b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oad the imag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10 Rectángulo"/>
          <p:cNvSpPr/>
          <p:nvPr/>
        </p:nvSpPr>
        <p:spPr>
          <a:xfrm>
            <a:off x="142920" y="6488280"/>
            <a:ext cx="900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D Slicer open source medical image analysis platform (</a:t>
            </a:r>
            <a:r>
              <a:rPr b="0" lang="en-US" sz="1400" spc="-1" strike="noStrike" u="sng">
                <a:solidFill>
                  <a:srgbClr val="0000ff"/>
                </a:solidFill>
                <a:uFillTx/>
                <a:latin typeface="Arial"/>
                <a:hlinkClick r:id="rId1"/>
              </a:rPr>
              <a:t>http://www.slicer.or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) Version: </a:t>
            </a: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4.1.1 r203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6" descr=""/>
          <p:cNvPicPr/>
          <p:nvPr/>
        </p:nvPicPr>
        <p:blipFill>
          <a:blip r:embed="rId2"/>
          <a:stretch/>
        </p:blipFill>
        <p:spPr>
          <a:xfrm>
            <a:off x="81000" y="2000160"/>
            <a:ext cx="8848800" cy="3438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3 CuadroTexto"/>
          <p:cNvSpPr/>
          <p:nvPr/>
        </p:nvSpPr>
        <p:spPr>
          <a:xfrm>
            <a:off x="71280" y="142920"/>
            <a:ext cx="8929800" cy="316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3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D Slicer Visualiza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2. Set Appropriate windows levels and display options for all images: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pen the Module “Volume” and then select an “Active Volume” in the left pane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You need to adjust the display options for each volume at a time (Brain,T1, and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ost-implant CT) in the visualization panel selecting the pin icon on the superior left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rner of any multiplanar visualization area. Then select the arrow to let you set the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ransparency level to 100% for the background layer. At that point you will be able to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djust the appropriate window and contrast level for the selected dataset back in the left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olume “display” panel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2" descr=""/>
          <p:cNvPicPr/>
          <p:nvPr/>
        </p:nvPicPr>
        <p:blipFill>
          <a:blip r:embed="rId1"/>
          <a:srcRect l="10417" t="5833" r="4165" b="6669"/>
          <a:stretch/>
        </p:blipFill>
        <p:spPr>
          <a:xfrm>
            <a:off x="3533760" y="3143160"/>
            <a:ext cx="5467320" cy="3500640"/>
          </a:xfrm>
          <a:prstGeom prst="rect">
            <a:avLst/>
          </a:prstGeom>
          <a:ln w="0">
            <a:noFill/>
          </a:ln>
        </p:spPr>
      </p:pic>
      <p:sp>
        <p:nvSpPr>
          <p:cNvPr id="55" name="6 CuadroTexto"/>
          <p:cNvSpPr/>
          <p:nvPr/>
        </p:nvSpPr>
        <p:spPr>
          <a:xfrm>
            <a:off x="71280" y="3359160"/>
            <a:ext cx="3429000" cy="374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is process needs to be adjusted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or each volume, changing to a different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“Active Volume” at a time on the left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olume panel and also in the background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ayer of the 2D visualization are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or the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mparc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LabelMap only, you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eed to set the Freesurfers labels in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 Display option Lookup table. Then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lect this volume in the Label Layer  and set  an accurate transparency threshold to be appropriately displayed.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ote that moving the mouse pointer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roughout this volume displays the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natomical region involved in the Data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be panel on the lef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1 CuadroTexto"/>
          <p:cNvSpPr/>
          <p:nvPr/>
        </p:nvSpPr>
        <p:spPr>
          <a:xfrm>
            <a:off x="0" y="71280"/>
            <a:ext cx="9115560" cy="350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4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D Slicer Registra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Rigid and Affine registration between T1 Pre-implant Brain MRI and Post-implant </a:t>
            </a:r>
            <a:br>
              <a:rPr sz="1800"/>
            </a:b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CT using BRAINSFi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fter checking and adjusting the correct volumes orientation of the post-implant CT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Moving Image) respect to the T1.mgz (Fixed Image) go to the “General Registration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BRAINS)” Module. Configure Moving and Fixed images accordingly, select ”Create new volume”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s the Output image. Then set “Initial Transformation: to None” and “use Center of the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d” , and “Registration Phases” as shown below. Finally “Apply” and check the result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8" descr=""/>
          <p:cNvPicPr/>
          <p:nvPr/>
        </p:nvPicPr>
        <p:blipFill>
          <a:blip r:embed="rId1"/>
          <a:srcRect l="18231" t="28333" r="1039" b="15000"/>
          <a:stretch/>
        </p:blipFill>
        <p:spPr>
          <a:xfrm>
            <a:off x="357120" y="2928960"/>
            <a:ext cx="8429760" cy="3699000"/>
          </a:xfrm>
          <a:prstGeom prst="rect">
            <a:avLst/>
          </a:prstGeom>
          <a:ln w="0">
            <a:noFill/>
          </a:ln>
        </p:spPr>
      </p:pic>
      <p:sp>
        <p:nvSpPr>
          <p:cNvPr id="58" name="9 CuadroTexto"/>
          <p:cNvSpPr/>
          <p:nvPr/>
        </p:nvSpPr>
        <p:spPr>
          <a:xfrm>
            <a:off x="3414240" y="6500880"/>
            <a:ext cx="175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st-implantC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10 CuadroTexto"/>
          <p:cNvSpPr/>
          <p:nvPr/>
        </p:nvSpPr>
        <p:spPr>
          <a:xfrm>
            <a:off x="5653440" y="6500880"/>
            <a:ext cx="300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ew Registered CT Volum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1 CuadroTexto"/>
          <p:cNvSpPr/>
          <p:nvPr/>
        </p:nvSpPr>
        <p:spPr>
          <a:xfrm>
            <a:off x="67680" y="142920"/>
            <a:ext cx="9108360" cy="396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5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D Slicer ; 2D Identification of Intracranial Electrodes (IE´s) 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Each IE needs to be explored and navigated in the 2D Multiplanar Visualization </a:t>
            </a:r>
            <a:br>
              <a:rPr sz="1800"/>
            </a:b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Panel to show its relation with the underlying anatomy in the Data Probe section.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t the appropriate volume and transparency level for Background (new registered CT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olume), Label Map (wmparc 0,10) and Front layers (Brain 0,70) as described in the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sualization Step 3.2, (See screen capture below).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E´s can be arbitrary colored in the “Volume” module, select the “new registered CT” as active and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urn the “Lookup Table” to Red.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o show specific contact information on different 2D views, Toggle the Crosshair icon with active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avigation/intersection and then click the desired position to reveal the anatomical location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5" descr=""/>
          <p:cNvPicPr/>
          <p:nvPr/>
        </p:nvPicPr>
        <p:blipFill>
          <a:blip r:embed="rId1"/>
          <a:srcRect l="11459" t="37501" r="6249" b="12502"/>
          <a:stretch/>
        </p:blipFill>
        <p:spPr>
          <a:xfrm>
            <a:off x="71280" y="3429000"/>
            <a:ext cx="8896680" cy="3378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1 CuadroTexto"/>
          <p:cNvSpPr/>
          <p:nvPr/>
        </p:nvSpPr>
        <p:spPr>
          <a:xfrm>
            <a:off x="28440" y="142920"/>
            <a:ext cx="8901360" cy="329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6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D Slicer ; 3D Renders of Intracranial Electrodes 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Electrodes can be superimposed over 3D pial reconstructions obtained from </a:t>
            </a:r>
            <a:br>
              <a:rPr sz="1800"/>
            </a:b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Freesurfer for better evalu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D renders helps to globally localize the electrodes when the operator is not aware of the surgical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mplantation planning or when the final implantation is uncertain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pen the “Volume Rendering” Module , select the “new registered CT” volume that contains the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E´s an then click on the “Eye icon” to show the overlay in the 3D visualization panel.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t may be necessary to scroll the “Shift” bar to set an appropriate display.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n the 3D render can be rotated, zoomed and Cropped conveniently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2" descr=""/>
          <p:cNvPicPr/>
          <p:nvPr/>
        </p:nvPicPr>
        <p:blipFill>
          <a:blip r:embed="rId1"/>
          <a:srcRect l="11381" t="25003" r="5207" b="17503"/>
          <a:stretch/>
        </p:blipFill>
        <p:spPr>
          <a:xfrm>
            <a:off x="142920" y="3081240"/>
            <a:ext cx="8929800" cy="38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1 CuadroTexto"/>
          <p:cNvSpPr/>
          <p:nvPr/>
        </p:nvSpPr>
        <p:spPr>
          <a:xfrm>
            <a:off x="28440" y="-71280"/>
            <a:ext cx="9115560" cy="350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ep 7: </a:t>
            </a: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ptional; Registration to standardized template for group analysi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Registration of IE´s to MNI coordinates 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ew aligned Post-Implant CT volume and T1 images are exported from 3Dslicer. (File/Save option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hen both images are transformed using (affine and non-linear registration) under “Normalise (Estimate and Write) ” utility to a T1 MNI Template (</a:t>
            </a:r>
            <a:r>
              <a:rPr b="0" lang="es-ES" sz="1600" spc="-1" strike="noStrike">
                <a:solidFill>
                  <a:srgbClr val="000000"/>
                </a:solidFill>
                <a:latin typeface="Arial"/>
              </a:rPr>
              <a:t>icbm152*)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in SPM8 (http://www.fil.ion.ucl.ac.uk/spm/software/spm8/). Source Image: T1MRI, Image to Write: Post-implant CT, Template Image: T1.nii*(Available in the SPM directory). See bottom Left imag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5 Rectángulo"/>
          <p:cNvSpPr/>
          <p:nvPr/>
        </p:nvSpPr>
        <p:spPr>
          <a:xfrm>
            <a:off x="285840" y="6581880"/>
            <a:ext cx="885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* 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Copyright (C) 1993–2004 Louis Collins, McConnell Brain Imaging Centre, Montreal Neurological Institute, McGill Universit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6" descr=""/>
          <p:cNvPicPr/>
          <p:nvPr/>
        </p:nvPicPr>
        <p:blipFill>
          <a:blip r:embed="rId1"/>
          <a:srcRect l="33333" t="1424" r="26564" b="5001"/>
          <a:stretch/>
        </p:blipFill>
        <p:spPr>
          <a:xfrm>
            <a:off x="6786720" y="2143080"/>
            <a:ext cx="2286000" cy="333396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7" descr=""/>
          <p:cNvPicPr/>
          <p:nvPr/>
        </p:nvPicPr>
        <p:blipFill>
          <a:blip r:embed="rId2"/>
          <a:srcRect l="2084" t="7500" r="41147" b="20833"/>
          <a:stretch/>
        </p:blipFill>
        <p:spPr>
          <a:xfrm>
            <a:off x="142920" y="2143080"/>
            <a:ext cx="4643280" cy="36640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7" descr=""/>
          <p:cNvPicPr/>
          <p:nvPr/>
        </p:nvPicPr>
        <p:blipFill>
          <a:blip r:embed="rId3"/>
          <a:srcRect l="65627" t="10003" r="6249" b="48335"/>
          <a:stretch/>
        </p:blipFill>
        <p:spPr>
          <a:xfrm>
            <a:off x="4786200" y="2286000"/>
            <a:ext cx="2006640" cy="185724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6" descr=""/>
          <p:cNvPicPr/>
          <p:nvPr/>
        </p:nvPicPr>
        <p:blipFill>
          <a:blip r:embed="rId4"/>
          <a:srcRect l="37094" t="59312" r="49289" b="30668"/>
          <a:stretch/>
        </p:blipFill>
        <p:spPr>
          <a:xfrm>
            <a:off x="4857840" y="4143240"/>
            <a:ext cx="3260520" cy="1500480"/>
          </a:xfrm>
          <a:prstGeom prst="rect">
            <a:avLst/>
          </a:prstGeom>
          <a:ln w="0">
            <a:noFill/>
          </a:ln>
        </p:spPr>
      </p:pic>
      <p:sp>
        <p:nvSpPr>
          <p:cNvPr id="70" name="10 Rectángulo"/>
          <p:cNvSpPr/>
          <p:nvPr/>
        </p:nvSpPr>
        <p:spPr>
          <a:xfrm>
            <a:off x="5715000" y="4786200"/>
            <a:ext cx="2214720" cy="28584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12 CuadroTexto"/>
          <p:cNvSpPr/>
          <p:nvPr/>
        </p:nvSpPr>
        <p:spPr>
          <a:xfrm>
            <a:off x="857160" y="5845320"/>
            <a:ext cx="80726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sualization using “Display” function: Ictal onset contact is selected for Patient 1; MNI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ordinates are automatically displayed. (see Right Image).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2T13:12:21Z</dcterms:created>
  <dc:creator>Hostital Ramos Mejia</dc:creator>
  <dc:description/>
  <dc:language>en-US</dc:language>
  <cp:lastModifiedBy>Hostital Ramos Mejia</cp:lastModifiedBy>
  <dcterms:modified xsi:type="dcterms:W3CDTF">2013-11-30T20:02:12Z</dcterms:modified>
  <cp:revision>82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